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80" d="100"/>
          <a:sy n="180" d="100"/>
        </p:scale>
        <p:origin x="-1158" y="46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93889-DFB1-4E85-A19C-F1F021825164}" type="datetimeFigureOut">
              <a:rPr lang="ko-KR" altLang="en-US" smtClean="0"/>
              <a:pPr/>
              <a:t>2019-11-04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072A6-C7C2-4039-A92F-263B9DA94AC1}" type="slidenum">
              <a:rPr lang="ko-KR" altLang="en-US" smtClean="0"/>
              <a:pPr/>
              <a:t>‹#›</a:t>
            </a:fld>
            <a:endParaRPr lang="ko-KR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 dirty="0"/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 dirty="0"/>
          </a:p>
        </p:txBody>
      </p:sp>
      <p:sp>
        <p:nvSpPr>
          <p:cNvPr id="73" name="TextBox 72"/>
          <p:cNvSpPr txBox="1"/>
          <p:nvPr/>
        </p:nvSpPr>
        <p:spPr>
          <a:xfrm>
            <a:off x="249324" y="7308304"/>
            <a:ext cx="60973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Supplementary figure 1.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Gas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chromatograms of the volatile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components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detected in (A) </a:t>
            </a:r>
            <a:r>
              <a:rPr lang="en-US" altLang="ko-K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eam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distilled essential oil (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SDEO</a:t>
            </a:r>
            <a:r>
              <a:rPr lang="en-US" altLang="ko-K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(B) glycosidically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bound aglycone fraction </a:t>
            </a:r>
            <a:r>
              <a:rPr lang="en-US" altLang="ko-KR" sz="120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BAF) isolated from </a:t>
            </a:r>
            <a:r>
              <a:rPr lang="en-US" sz="1200" i="1"/>
              <a:t>Maclura triscuspidata</a:t>
            </a:r>
            <a:r>
              <a:rPr lang="en-US" altLang="ko-KR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1" name="그룹 40"/>
          <p:cNvGrpSpPr/>
          <p:nvPr/>
        </p:nvGrpSpPr>
        <p:grpSpPr>
          <a:xfrm>
            <a:off x="285728" y="992479"/>
            <a:ext cx="5879576" cy="6031273"/>
            <a:chOff x="285728" y="992479"/>
            <a:chExt cx="5879576" cy="6031273"/>
          </a:xfrm>
        </p:grpSpPr>
        <p:grpSp>
          <p:nvGrpSpPr>
            <p:cNvPr id="72" name="그룹 71"/>
            <p:cNvGrpSpPr/>
            <p:nvPr/>
          </p:nvGrpSpPr>
          <p:grpSpPr>
            <a:xfrm>
              <a:off x="285728" y="992479"/>
              <a:ext cx="5879576" cy="6031273"/>
              <a:chOff x="285728" y="532759"/>
              <a:chExt cx="6120000" cy="6490993"/>
            </a:xfrm>
          </p:grpSpPr>
          <p:grpSp>
            <p:nvGrpSpPr>
              <p:cNvPr id="70" name="그룹 69"/>
              <p:cNvGrpSpPr/>
              <p:nvPr/>
            </p:nvGrpSpPr>
            <p:grpSpPr>
              <a:xfrm>
                <a:off x="285728" y="532759"/>
                <a:ext cx="6120000" cy="3240000"/>
                <a:chOff x="285728" y="604197"/>
                <a:chExt cx="6072230" cy="3181985"/>
              </a:xfrm>
            </p:grpSpPr>
            <p:pic>
              <p:nvPicPr>
                <p:cNvPr id="6" name="_x223734664" descr="EMB0000163c4523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 bwMode="auto">
                <a:xfrm>
                  <a:off x="285728" y="627057"/>
                  <a:ext cx="6072230" cy="315912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7" name="TextBox 6"/>
                <p:cNvSpPr txBox="1"/>
                <p:nvPr/>
              </p:nvSpPr>
              <p:spPr>
                <a:xfrm>
                  <a:off x="1635434" y="690874"/>
                  <a:ext cx="642942" cy="3578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Decanol</a:t>
                  </a:r>
                </a:p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(ISTD</a:t>
                  </a:r>
                  <a:r>
                    <a:rPr lang="ko-KR" altLang="en-US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 </a:t>
                  </a:r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)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793414" y="698495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642918" y="3198825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752456" y="2791927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676256" y="2818775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1199182" y="177006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1015348" y="315024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285860" y="69736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484934" y="69849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1484934" y="278543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3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1763066" y="1166951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7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1834504" y="2911943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986904" y="284163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2285992" y="68212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2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cxnSp>
              <p:nvCxnSpPr>
                <p:cNvPr id="21" name="직선 화살표 연결선 20"/>
                <p:cNvCxnSpPr/>
                <p:nvPr/>
              </p:nvCxnSpPr>
              <p:spPr>
                <a:xfrm rot="5400000">
                  <a:off x="2224793" y="902570"/>
                  <a:ext cx="229554" cy="10715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>
                  <a:off x="2278372" y="105568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5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428868" y="60419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2357430" y="307118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2658422" y="64229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2722240" y="91280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3065140" y="922333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 rot="10800000" flipV="1">
                  <a:off x="2745100" y="281591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2810822" y="79469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3229926" y="272161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7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857628" y="205581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571876" y="2627321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4286256" y="162718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3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230058" y="307005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2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4572008" y="769933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4714884" y="1555751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6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4842520" y="1604329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7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4857760" y="698495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5056834" y="769933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4128140" y="3157867"/>
                  <a:ext cx="3571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5857892" y="691488"/>
                  <a:ext cx="2143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A</a:t>
                  </a:r>
                  <a:endParaRPr lang="ko-KR" altLang="en-US" sz="14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71" name="그룹 70"/>
              <p:cNvGrpSpPr/>
              <p:nvPr/>
            </p:nvGrpSpPr>
            <p:grpSpPr>
              <a:xfrm>
                <a:off x="285728" y="3783752"/>
                <a:ext cx="6120000" cy="3240000"/>
                <a:chOff x="252390" y="4071934"/>
                <a:chExt cx="6105568" cy="3519488"/>
              </a:xfrm>
            </p:grpSpPr>
            <p:pic>
              <p:nvPicPr>
                <p:cNvPr id="1025" name="_x338136800" descr="EMB00000f94044f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252390" y="4071934"/>
                  <a:ext cx="6105568" cy="3519488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42" name="TextBox 41"/>
                <p:cNvSpPr txBox="1"/>
                <p:nvPr/>
              </p:nvSpPr>
              <p:spPr>
                <a:xfrm>
                  <a:off x="676256" y="4142242"/>
                  <a:ext cx="21431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1255380" y="412813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7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1247760" y="690546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1357298" y="6828310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1438260" y="657113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3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1928802" y="5736738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1667517" y="4098190"/>
                  <a:ext cx="642942" cy="39579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Decanol</a:t>
                  </a:r>
                </a:p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(ISTD</a:t>
                  </a:r>
                  <a:r>
                    <a:rPr lang="ko-KR" altLang="en-US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 </a:t>
                  </a:r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)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2143116" y="671877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2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357430" y="4130990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9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>
                  <a:off x="2564124" y="5658810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6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2913694" y="411938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5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2349810" y="695118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2729860" y="664257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2890834" y="5889138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5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2962272" y="4643438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2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3018470" y="6856886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3064190" y="694356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66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4827280" y="414337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8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4921578" y="6301752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9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3827148" y="583502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8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4041462" y="6390158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80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4161478" y="658750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81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3477578" y="6516066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3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3589974" y="6451118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3669032" y="6571134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5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5891230" y="5101416"/>
                  <a:ext cx="31623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94</a:t>
                  </a:r>
                  <a:endParaRPr lang="ko-KR" altLang="en-US" sz="8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5873132" y="4151827"/>
                  <a:ext cx="21431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B</a:t>
                  </a:r>
                  <a:endParaRPr lang="ko-KR" altLang="en-US" sz="14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</p:grpSp>
        <p:cxnSp>
          <p:nvCxnSpPr>
            <p:cNvPr id="3" name="직선 화살표 연결선 2"/>
            <p:cNvCxnSpPr/>
            <p:nvPr/>
          </p:nvCxnSpPr>
          <p:spPr>
            <a:xfrm>
              <a:off x="1962962" y="1372782"/>
              <a:ext cx="172929" cy="1490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화살표 연결선 75"/>
            <p:cNvCxnSpPr/>
            <p:nvPr/>
          </p:nvCxnSpPr>
          <p:spPr>
            <a:xfrm>
              <a:off x="1988840" y="4350988"/>
              <a:ext cx="172929" cy="1490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</TotalTime>
  <Words>104</Words>
  <Application>Microsoft Office PowerPoint</Application>
  <PresentationFormat>화면 슬라이드 쇼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Registered User</dc:creator>
  <cp:lastModifiedBy>Registered User</cp:lastModifiedBy>
  <cp:revision>24</cp:revision>
  <dcterms:created xsi:type="dcterms:W3CDTF">2014-11-24T11:04:14Z</dcterms:created>
  <dcterms:modified xsi:type="dcterms:W3CDTF">2019-11-04T11:35:45Z</dcterms:modified>
</cp:coreProperties>
</file>